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70E2AC-57F6-482A-A20A-5CFFD1705B2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57B3F5-0486-49C2-BDB4-CE3FE02F0B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F890C4-051B-4DCD-BF40-DC1FC18286D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C7BD89-364E-433D-9C38-92B675C6202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03B597-3959-455C-8DEC-BA0A07C9D4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539CC6-8239-4BCE-B147-E0DF36F104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8208A2-9BA0-4F8A-A6A5-5A862ED36C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2AF4C1-63AD-47CA-A3B9-6499F7C28F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7C590A-4632-4CCE-BF76-AB9084ECDA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6F49ED-9024-45F5-B66D-E050DF8305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9FF361-A028-4629-B627-1FC624D00B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8EB8A9-CE98-4122-A02A-6EB5106D23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1B75ED-65B4-4DF6-A5E7-7C6946EA83E6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矩形 1"/>
          <p:cNvSpPr/>
          <p:nvPr/>
        </p:nvSpPr>
        <p:spPr>
          <a:xfrm>
            <a:off x="285840" y="285840"/>
            <a:ext cx="8429400" cy="585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Gene Ontology (GO) term “enrichment status” for targets of  pollen– and sporophyte-enriched kn-miRNA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,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term enrichment levels along with the GO term hierarchy within the “biological process” branch in targets of pollen-enriched kn-miRNAs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B,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term enrichment levels along with the GO term hierarchy within the “cellular component” branch in targets of pollen-enriched kn-miRNA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C,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term enrichment levels along with the GO term hierarchy within the “molecular function” branch in targets of pollen-enriched kn-miRNAs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D,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term enrichment levels along with the GO term hierarchy within the “biological process” branch in targets of sporophyte-enriched kn-miRNAs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E,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term enrichment levels along with the GO term hierarchy within the “cellular component” branch in targets of sporophyte-enriched kn-miRNAs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,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term enrichment levels along with the GO term hierarchy within the “molecular function” branch targets of sporophyte-enriched kn-miRNAs;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G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, The color scale shows the p-value cutoff levels for each biological process, and the more significant statistically, and the color is darker and redder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he classification terms and their serial number are represented as rectangles. Inside the box of the significant terms, the information includes: GO term, adjusted p-value (in the bracket), item number mapping the GO in the query list and background, and total number of query list and background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Picture 2" descr="E:\文章\small RNAs\Manuscript 20100803\图与表0818\GO analysis of known miRNA\pollen enriched-老版本\232770118-biological process.png"/>
          <p:cNvPicPr/>
          <p:nvPr/>
        </p:nvPicPr>
        <p:blipFill>
          <a:blip r:embed="rId1"/>
          <a:stretch/>
        </p:blipFill>
        <p:spPr>
          <a:xfrm>
            <a:off x="0" y="260280"/>
            <a:ext cx="9144000" cy="4016520"/>
          </a:xfrm>
          <a:prstGeom prst="rect">
            <a:avLst/>
          </a:prstGeom>
          <a:ln w="0">
            <a:noFill/>
          </a:ln>
        </p:spPr>
      </p:pic>
      <p:sp>
        <p:nvSpPr>
          <p:cNvPr id="43" name="矩形 4"/>
          <p:cNvSpPr/>
          <p:nvPr/>
        </p:nvSpPr>
        <p:spPr>
          <a:xfrm>
            <a:off x="826920" y="5300640"/>
            <a:ext cx="7174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,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term enrichment levels along with the GO term hierarchy within the “biological process” branch in targets of pollen-enriched kn-miRNA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Picture 2" descr="E:\文章\small RNAs\Manuscript 20100803\图与表0818\GO analysis of known miRNA\pollen enriched-老版本\232770118-cellular component.png"/>
          <p:cNvPicPr/>
          <p:nvPr/>
        </p:nvPicPr>
        <p:blipFill>
          <a:blip r:embed="rId1"/>
          <a:stretch/>
        </p:blipFill>
        <p:spPr>
          <a:xfrm>
            <a:off x="1187280" y="333360"/>
            <a:ext cx="5195880" cy="5359320"/>
          </a:xfrm>
          <a:prstGeom prst="rect">
            <a:avLst/>
          </a:prstGeom>
          <a:ln w="0">
            <a:noFill/>
          </a:ln>
        </p:spPr>
      </p:pic>
      <p:sp>
        <p:nvSpPr>
          <p:cNvPr id="45" name="矩形 2"/>
          <p:cNvSpPr/>
          <p:nvPr/>
        </p:nvSpPr>
        <p:spPr>
          <a:xfrm>
            <a:off x="900000" y="5877000"/>
            <a:ext cx="74883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B,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term enrichment levels along with the GO term hierarchy within the “cellular component” branch in targets of pollen-enriched kno-miRNA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2" descr="E:\文章\small RNAs\Manuscript 20100803\图与表0818\GO analysis of known miRNA\pollen enriched-老版本\232770118-molecular function.png"/>
          <p:cNvPicPr/>
          <p:nvPr/>
        </p:nvPicPr>
        <p:blipFill>
          <a:blip r:embed="rId1"/>
          <a:stretch/>
        </p:blipFill>
        <p:spPr>
          <a:xfrm>
            <a:off x="2643120" y="428760"/>
            <a:ext cx="3095640" cy="5105160"/>
          </a:xfrm>
          <a:prstGeom prst="rect">
            <a:avLst/>
          </a:prstGeom>
          <a:ln w="0">
            <a:noFill/>
          </a:ln>
        </p:spPr>
      </p:pic>
      <p:sp>
        <p:nvSpPr>
          <p:cNvPr id="47" name="矩形 2"/>
          <p:cNvSpPr/>
          <p:nvPr/>
        </p:nvSpPr>
        <p:spPr>
          <a:xfrm>
            <a:off x="900000" y="5877000"/>
            <a:ext cx="72867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C,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term enrichment levels along with the GO term hierarchy within the “molecular function” branch in targets of pollen-enriched kno-miRNA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E:\文章\small RNAs\Manuscript 20100803\图与表0818\GO analysis of known miRNA\sporophyte enriched-老版本\541658044-biological process.png"/>
          <p:cNvPicPr/>
          <p:nvPr/>
        </p:nvPicPr>
        <p:blipFill>
          <a:blip r:embed="rId1"/>
          <a:stretch/>
        </p:blipFill>
        <p:spPr>
          <a:xfrm>
            <a:off x="-33480" y="0"/>
            <a:ext cx="9177480" cy="5816520"/>
          </a:xfrm>
          <a:prstGeom prst="rect">
            <a:avLst/>
          </a:prstGeom>
          <a:ln w="0">
            <a:noFill/>
          </a:ln>
        </p:spPr>
      </p:pic>
      <p:sp>
        <p:nvSpPr>
          <p:cNvPr id="49" name="矩形 2"/>
          <p:cNvSpPr/>
          <p:nvPr/>
        </p:nvSpPr>
        <p:spPr>
          <a:xfrm>
            <a:off x="214200" y="6211800"/>
            <a:ext cx="9144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D,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term enrichment levels along with the GO term hierarchy within the “biological process” branch in targets of sporophyte-enriched kn-miRNA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2" descr="E:\文章\small RNAs\Manuscript 20100803\图与表0818\GO analysis of known miRNA\sporophyte enriched-老版本\541658044-component.png"/>
          <p:cNvPicPr/>
          <p:nvPr/>
        </p:nvPicPr>
        <p:blipFill>
          <a:blip r:embed="rId1"/>
          <a:stretch/>
        </p:blipFill>
        <p:spPr>
          <a:xfrm>
            <a:off x="1500120" y="0"/>
            <a:ext cx="5262480" cy="5864400"/>
          </a:xfrm>
          <a:prstGeom prst="rect">
            <a:avLst/>
          </a:prstGeom>
          <a:ln w="0">
            <a:noFill/>
          </a:ln>
        </p:spPr>
      </p:pic>
      <p:sp>
        <p:nvSpPr>
          <p:cNvPr id="51" name="矩形 2"/>
          <p:cNvSpPr/>
          <p:nvPr/>
        </p:nvSpPr>
        <p:spPr>
          <a:xfrm>
            <a:off x="500040" y="6211800"/>
            <a:ext cx="86439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E,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term enrichment levels along with the GO term hierarchy within the “cellular component” branch in targets of sporophyte-enriched kn-miRNA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2" descr="E:\文章\small RNAs\Manuscript 20100803\图与表0818\GO analysis of known miRNA\sporophyte enriched-老版本\541658044-molecular function.png"/>
          <p:cNvPicPr/>
          <p:nvPr/>
        </p:nvPicPr>
        <p:blipFill>
          <a:blip r:embed="rId1"/>
          <a:stretch/>
        </p:blipFill>
        <p:spPr>
          <a:xfrm>
            <a:off x="1357200" y="0"/>
            <a:ext cx="6272280" cy="6342120"/>
          </a:xfrm>
          <a:prstGeom prst="rect">
            <a:avLst/>
          </a:prstGeom>
          <a:ln w="0">
            <a:noFill/>
          </a:ln>
        </p:spPr>
      </p:pic>
      <p:sp>
        <p:nvSpPr>
          <p:cNvPr id="53" name="矩形 2"/>
          <p:cNvSpPr/>
          <p:nvPr/>
        </p:nvSpPr>
        <p:spPr>
          <a:xfrm>
            <a:off x="571680" y="6211800"/>
            <a:ext cx="7858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,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term enrichment levels along with the GO term hierarchy within the “molecular function” branch targets of sporophyte-enriched kn-miRNAs;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Picture 2" descr="C:\Documents and Settings\Administrator\桌面\未标题-1.jpg"/>
          <p:cNvPicPr/>
          <p:nvPr/>
        </p:nvPicPr>
        <p:blipFill>
          <a:blip r:embed="rId1"/>
          <a:stretch/>
        </p:blipFill>
        <p:spPr>
          <a:xfrm>
            <a:off x="1428840" y="642960"/>
            <a:ext cx="6154560" cy="4000320"/>
          </a:xfrm>
          <a:prstGeom prst="rect">
            <a:avLst/>
          </a:prstGeom>
          <a:ln w="0">
            <a:noFill/>
          </a:ln>
        </p:spPr>
      </p:pic>
      <p:sp>
        <p:nvSpPr>
          <p:cNvPr id="55" name="矩形 3"/>
          <p:cNvSpPr/>
          <p:nvPr/>
        </p:nvSpPr>
        <p:spPr>
          <a:xfrm>
            <a:off x="1643040" y="4929120"/>
            <a:ext cx="6072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G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, The color scale shows the p-value cutoff levels for each biological process, and the more significant statistically, and the color is darker and redder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02T01:26:09Z</dcterms:created>
  <dc:creator>微软用户</dc:creator>
  <dc:description/>
  <dc:language>en-US</dc:language>
  <cp:lastModifiedBy>微软用户</cp:lastModifiedBy>
  <dcterms:modified xsi:type="dcterms:W3CDTF">2011-03-31T07:17:26Z</dcterms:modified>
  <cp:revision>8</cp:revision>
  <dc:subject/>
  <dc:title>幻灯片 1</dc:title>
</cp:coreProperties>
</file>